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A5E1EE8-348F-4BDE-9BF3-9D24DDD2F4CE}" v="1" dt="2023-04-20T01:26:10.7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ghapour, Ehsan" userId="347c9d7f-96de-4b56-a679-037b3172993a" providerId="ADAL" clId="{AA5E1EE8-348F-4BDE-9BF3-9D24DDD2F4CE}"/>
    <pc:docChg chg="undo custSel modSld">
      <pc:chgData name="Saghapour, Ehsan" userId="347c9d7f-96de-4b56-a679-037b3172993a" providerId="ADAL" clId="{AA5E1EE8-348F-4BDE-9BF3-9D24DDD2F4CE}" dt="2023-04-20T01:26:10.756" v="4" actId="1076"/>
      <pc:docMkLst>
        <pc:docMk/>
      </pc:docMkLst>
      <pc:sldChg chg="modSp mod">
        <pc:chgData name="Saghapour, Ehsan" userId="347c9d7f-96de-4b56-a679-037b3172993a" providerId="ADAL" clId="{AA5E1EE8-348F-4BDE-9BF3-9D24DDD2F4CE}" dt="2023-04-20T01:26:10.756" v="4" actId="1076"/>
        <pc:sldMkLst>
          <pc:docMk/>
          <pc:sldMk cId="3644545426" sldId="257"/>
        </pc:sldMkLst>
        <pc:spChg chg="mod">
          <ac:chgData name="Saghapour, Ehsan" userId="347c9d7f-96de-4b56-a679-037b3172993a" providerId="ADAL" clId="{AA5E1EE8-348F-4BDE-9BF3-9D24DDD2F4CE}" dt="2023-04-20T01:25:56.856" v="3" actId="20577"/>
          <ac:spMkLst>
            <pc:docMk/>
            <pc:sldMk cId="3644545426" sldId="257"/>
            <ac:spMk id="5" creationId="{5052E626-1E3C-2364-C379-556092E019C7}"/>
          </ac:spMkLst>
        </pc:spChg>
        <pc:picChg chg="mod">
          <ac:chgData name="Saghapour, Ehsan" userId="347c9d7f-96de-4b56-a679-037b3172993a" providerId="ADAL" clId="{AA5E1EE8-348F-4BDE-9BF3-9D24DDD2F4CE}" dt="2023-04-20T01:26:10.756" v="4" actId="1076"/>
          <ac:picMkLst>
            <pc:docMk/>
            <pc:sldMk cId="3644545426" sldId="257"/>
            <ac:picMk id="1025" creationId="{17EA3B71-C7C9-1B4E-6633-44A177ABE81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69F3A-8C70-28DA-456C-322214F037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4EF626-4DEC-98E0-D5A1-667F07705B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B995A5-E0F8-E299-F9B8-8EC30664B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BFF5C-48E3-E63A-CE4C-8E3599E71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185B85-5D81-47B2-89CA-EF80FE235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249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E38A0-F009-50A7-7378-E39F92149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A9189B-00CE-3940-C15C-049835EE34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068BA3-CAED-7EDC-B479-2B27FE27F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4C593-9D92-DAFC-F86F-E370388A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7E075-EDF1-8098-2F2B-EBC0DFEA5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17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E9FE44-285E-8305-FAB7-20853B51D5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5EE129-BB5C-385E-00B4-418606522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5A136-B261-83D1-D9EB-EC086B1A5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28FAD-7B3A-AD52-6EDC-F21CEBDEC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2A6DE-2456-2511-E012-3A978147F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258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B896F-FF6C-D02D-1B0A-9CAEB69DA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F0576A-C082-A1A8-197F-C262CA7893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A57FBA-A253-8514-8AD8-9605A9782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EA53E-C01E-42B2-A0D3-FB1D18B36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D2B49A-8653-EA6C-5568-18241F749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416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432BC-FC27-D392-B72A-B589BA7EB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48F608-8E83-F652-5083-FD348DC8A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70FA1-ACDB-7316-5DF5-E5120341E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35806-EC1A-99B1-382D-3399199F9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689C5C-3068-E7FD-B293-619F690C3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783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F8707-8C89-A484-6E6D-D9F639690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43F926-4BBA-DD6C-09B6-1C2838E026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B88974-1750-6573-D6A6-83306C9F20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A087C0-09FB-F99D-53AC-3D42DBDA6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DD330E-5E74-8FCC-71CD-EF329970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BDFCAC-0109-4CD4-8706-9BD41D0CB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717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9EB00-22A5-3847-7265-919DE5C05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A08EFA-04D9-E2E6-499A-0B590391CF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D6E8D3-EE6F-464D-E87B-EAD70312D6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417FCD-2447-1F6A-AE38-4EE2C3A81D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4AB3C5-D19B-F620-9AE0-4D62FE1445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33C85E-EF44-F0C4-71A2-F0897477D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FEBCEB-DDFF-AEFC-C3A0-4872B76F8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AAD8B4-BCDE-F561-80E2-5C9C1B9E7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78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B3C70C-D476-12FF-4579-EBD20DC86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A3E264-ADF8-98FE-046B-A647B91D8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CF8B21-CBCC-6D91-5F63-620DDC17A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0E9C29-137B-8F0F-7381-0FAE57274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917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0A7447-E7C9-4BC2-BDCC-465263B2D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64DCC3-B400-423D-2DE7-A738EE029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0832D8-B65A-78F1-FABC-33BD3DB51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26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D1F54-735C-1594-E98D-7A0CC58E2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6E85C5-4F2A-49C5-AEB6-35A788E9FF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0E2314-9895-CBF4-1289-3CE296DE7B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25F6AC-B404-7F2F-3295-80D35E353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B27856-3CF2-85AE-5322-73D73C7E0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EBC761-10BC-3065-3F05-670C4504B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136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31FA0-5B16-2DA7-72C8-8E957EC3CC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E5AC24-040E-C3C4-C34E-82D347E5D4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4940A1-20C5-97FF-3AE7-AB5F5A26CE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709149-FE97-A7DF-3058-67708EC44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189755-A72F-8B49-A656-00BE8A7A5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752E58-23FA-DF64-BAB5-EDFD25E2E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402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B53A0A-688D-94D4-18BD-337C52878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D7CEEC-3FC3-2147-BDE9-0C258CCC5B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61FC0E-B1CD-2339-9258-67750EAC24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AAC27-C0CC-4488-B4A5-A2504781DD36}" type="datetimeFigureOut">
              <a:rPr lang="en-US" smtClean="0"/>
              <a:t>4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B24AF-3C53-E2F2-FE09-0A9ED86B09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769508-219F-9589-15DC-3FD3205005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B865B-C753-44EC-ACCE-202B8C2E74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35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E58C8-91B4-B3FB-8B9C-31E21565A0C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1</a:t>
            </a:r>
          </a:p>
        </p:txBody>
      </p:sp>
    </p:spTree>
    <p:extLst>
      <p:ext uri="{BB962C8B-B14F-4D97-AF65-F5344CB8AC3E}">
        <p14:creationId xmlns:p14="http://schemas.microsoft.com/office/powerpoint/2010/main" val="816817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CF1E7F62-4CE3-683C-73DE-957910684A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4" descr="Chart&#10;&#10;Description automatically generated">
            <a:extLst>
              <a:ext uri="{FF2B5EF4-FFF2-40B4-BE49-F238E27FC236}">
                <a16:creationId xmlns:a16="http://schemas.microsoft.com/office/drawing/2014/main" id="{17EA3B71-C7C9-1B4E-6633-44A177ABE8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2"/>
          <a:stretch>
            <a:fillRect/>
          </a:stretch>
        </p:blipFill>
        <p:spPr bwMode="auto">
          <a:xfrm>
            <a:off x="3256383" y="153955"/>
            <a:ext cx="5150497" cy="4713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5052E626-1E3C-2364-C379-556092E019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4992" y="5126076"/>
            <a:ext cx="717524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1. The constructed layout (graph) for the GBM cancer dataset using the DEMA Layout. The value of kb/ka= 912 and the value of Kc=9120.</a:t>
            </a:r>
            <a:endParaRPr kumimoji="0" lang="en-US" altLang="en-US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45454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Diagram&#10;&#10;Description automatically generated">
            <a:extLst>
              <a:ext uri="{FF2B5EF4-FFF2-40B4-BE49-F238E27FC236}">
                <a16:creationId xmlns:a16="http://schemas.microsoft.com/office/drawing/2014/main" id="{34BD0982-D520-80F8-A296-8152CA067D57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69543" y="148166"/>
            <a:ext cx="5167164" cy="5571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E2B6FC7-D9A9-CA8A-3EFC-32DCB627BF04}"/>
              </a:ext>
            </a:extLst>
          </p:cNvPr>
          <p:cNvSpPr txBox="1"/>
          <p:nvPr/>
        </p:nvSpPr>
        <p:spPr>
          <a:xfrm>
            <a:off x="3281266" y="589034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Figure 2. Generating GTKMs and a GTKM Profile</a:t>
            </a:r>
          </a:p>
        </p:txBody>
      </p:sp>
    </p:spTree>
    <p:extLst>
      <p:ext uri="{BB962C8B-B14F-4D97-AF65-F5344CB8AC3E}">
        <p14:creationId xmlns:p14="http://schemas.microsoft.com/office/powerpoint/2010/main" val="1590003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C630720E-32B0-E040-31DB-87D85C1700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4" descr="Shape&#10;&#10;Description automatically generated">
            <a:extLst>
              <a:ext uri="{FF2B5EF4-FFF2-40B4-BE49-F238E27FC236}">
                <a16:creationId xmlns:a16="http://schemas.microsoft.com/office/drawing/2014/main" id="{23BE77F5-EAED-01CA-78BF-F72421E27CA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2473" y="373224"/>
            <a:ext cx="9107054" cy="48332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79A2B4C9-4F62-7F4E-C104-610701D3B1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5662" y="5579706"/>
            <a:ext cx="745671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3. A) concept of Geneterrain. B) Effect of sigma on Geneterrain</a:t>
            </a:r>
            <a:endParaRPr kumimoji="0" lang="en-US" altLang="en-US" sz="2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781B069-C586-031D-8FB2-19A0329FA510}"/>
              </a:ext>
            </a:extLst>
          </p:cNvPr>
          <p:cNvSpPr/>
          <p:nvPr/>
        </p:nvSpPr>
        <p:spPr>
          <a:xfrm>
            <a:off x="1542473" y="2789853"/>
            <a:ext cx="267666" cy="2425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CFC6E54-5A8B-79AB-DBE9-A3EBC357ABD9}"/>
              </a:ext>
            </a:extLst>
          </p:cNvPr>
          <p:cNvSpPr/>
          <p:nvPr/>
        </p:nvSpPr>
        <p:spPr>
          <a:xfrm>
            <a:off x="1505151" y="4789714"/>
            <a:ext cx="267666" cy="2425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AB733B-3BDE-0AE7-9017-879F57832A60}"/>
              </a:ext>
            </a:extLst>
          </p:cNvPr>
          <p:cNvSpPr txBox="1"/>
          <p:nvPr/>
        </p:nvSpPr>
        <p:spPr>
          <a:xfrm>
            <a:off x="1054078" y="228600"/>
            <a:ext cx="289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62C499-AB9B-11FB-0538-B79276A6F3CB}"/>
              </a:ext>
            </a:extLst>
          </p:cNvPr>
          <p:cNvSpPr txBox="1"/>
          <p:nvPr/>
        </p:nvSpPr>
        <p:spPr>
          <a:xfrm>
            <a:off x="1153651" y="2726485"/>
            <a:ext cx="289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29885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64</Words>
  <Application>Microsoft Office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ry 1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1</dc:title>
  <dc:creator>Saghapour, Ehsan</dc:creator>
  <cp:lastModifiedBy>Saghapour, Ehsan</cp:lastModifiedBy>
  <cp:revision>3</cp:revision>
  <dcterms:created xsi:type="dcterms:W3CDTF">2023-03-09T15:57:46Z</dcterms:created>
  <dcterms:modified xsi:type="dcterms:W3CDTF">2023-04-20T01:26:21Z</dcterms:modified>
</cp:coreProperties>
</file>